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244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6D15B-7D78-47DA-8442-F909B6B64E9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9162C-B5F8-4FD7-8BFD-DB68725107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657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6D15B-7D78-47DA-8442-F909B6B64E9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9162C-B5F8-4FD7-8BFD-DB68725107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937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6D15B-7D78-47DA-8442-F909B6B64E9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9162C-B5F8-4FD7-8BFD-DB68725107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544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6D15B-7D78-47DA-8442-F909B6B64E9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9162C-B5F8-4FD7-8BFD-DB68725107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94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6D15B-7D78-47DA-8442-F909B6B64E9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9162C-B5F8-4FD7-8BFD-DB68725107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9964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6D15B-7D78-47DA-8442-F909B6B64E9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9162C-B5F8-4FD7-8BFD-DB68725107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320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6D15B-7D78-47DA-8442-F909B6B64E9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9162C-B5F8-4FD7-8BFD-DB68725107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6D15B-7D78-47DA-8442-F909B6B64E9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9162C-B5F8-4FD7-8BFD-DB68725107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898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6D15B-7D78-47DA-8442-F909B6B64E9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9162C-B5F8-4FD7-8BFD-DB68725107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625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6D15B-7D78-47DA-8442-F909B6B64E9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9162C-B5F8-4FD7-8BFD-DB68725107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7020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6D15B-7D78-47DA-8442-F909B6B64E9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9162C-B5F8-4FD7-8BFD-DB68725107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602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6D15B-7D78-47DA-8442-F909B6B64E9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49162C-B5F8-4FD7-8BFD-DB68725107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202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17F52E9-FDA9-5C0E-123D-C30DDB51C276}"/>
              </a:ext>
            </a:extLst>
          </p:cNvPr>
          <p:cNvGrpSpPr/>
          <p:nvPr/>
        </p:nvGrpSpPr>
        <p:grpSpPr>
          <a:xfrm>
            <a:off x="1304841" y="442156"/>
            <a:ext cx="4325257" cy="7680960"/>
            <a:chOff x="1304841" y="442156"/>
            <a:chExt cx="4325257" cy="768096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C639CB3-3BC2-D570-27E1-D365A771F6F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04841" y="442156"/>
              <a:ext cx="4248318" cy="256032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CF1ECD9-E514-419F-DD1F-B892A17A078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68588" y="3002476"/>
              <a:ext cx="4261510" cy="256032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07574ED-437E-61DF-F1CC-1B963606A05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368588" y="5562796"/>
              <a:ext cx="4261510" cy="2560320"/>
            </a:xfrm>
            <a:prstGeom prst="rect">
              <a:avLst/>
            </a:prstGeom>
          </p:spPr>
        </p:pic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703E9C74-7E5F-58CE-E950-5751CE7D5CBE}"/>
              </a:ext>
            </a:extLst>
          </p:cNvPr>
          <p:cNvSpPr txBox="1"/>
          <p:nvPr/>
        </p:nvSpPr>
        <p:spPr>
          <a:xfrm>
            <a:off x="228599" y="97038"/>
            <a:ext cx="2004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89"/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. Fig. 7_part 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F4190A5-2B81-570C-E9DB-14E42EAAFC22}"/>
              </a:ext>
            </a:extLst>
          </p:cNvPr>
          <p:cNvSpPr txBox="1"/>
          <p:nvPr/>
        </p:nvSpPr>
        <p:spPr>
          <a:xfrm>
            <a:off x="228598" y="8031299"/>
            <a:ext cx="6468763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7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xpression level in ‘Granny Smith’ (white bar) and ‘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adina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’ (grey bar) apple cultivars of genes related to fermentative processes. The error bars correspond to the standard deviation. RA= Regular Atmosphere; 1-MCP= Regular Atmosphere + 1-MCP treatment; LO= Low Oxygen condition. FPKM= fragments per kilobase of transcript per million fragments mapped. Continued in the second pag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20829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B22BF10-CA7C-A0F4-C251-C35617E677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97760"/>
            <a:ext cx="3505199" cy="210312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DF0473E-DB15-5CF7-8D42-7248300D6F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57472" y="597760"/>
            <a:ext cx="3500527" cy="210312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97C9D9D-3571-F272-8CDF-0D195FB00E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52801" y="2700880"/>
            <a:ext cx="3500527" cy="210312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698CD16-5A62-978F-0C26-E50264F9BFC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72" y="2700880"/>
            <a:ext cx="3500527" cy="210312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B5F4D18-505D-E6FD-938D-8CBF4ED1A154}"/>
              </a:ext>
            </a:extLst>
          </p:cNvPr>
          <p:cNvSpPr txBox="1"/>
          <p:nvPr/>
        </p:nvSpPr>
        <p:spPr>
          <a:xfrm>
            <a:off x="316523" y="7153305"/>
            <a:ext cx="6447692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7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xpression level in ‘Granny Smith’ (white bar) and ‘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adina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’ (grey bar) apple cultivars of genes related to fermentative processes. The error bars correspond to the standard deviation. RA= Regular Atmosphere; 1-MCP= Regular Atmosphere + 1-MCP treatment; LO= Low Oxygen condition. FPKM= fragments per kilobase of transcript per million fragments mapped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A18C4A4-60C0-7CA5-EEEE-96429693628C}"/>
              </a:ext>
            </a:extLst>
          </p:cNvPr>
          <p:cNvSpPr txBox="1"/>
          <p:nvPr/>
        </p:nvSpPr>
        <p:spPr>
          <a:xfrm>
            <a:off x="228599" y="97038"/>
            <a:ext cx="2004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89"/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. Fig. 7_part II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4EC69679-385B-6000-A0FD-FCEE71909E6C}"/>
              </a:ext>
            </a:extLst>
          </p:cNvPr>
          <p:cNvGrpSpPr/>
          <p:nvPr/>
        </p:nvGrpSpPr>
        <p:grpSpPr>
          <a:xfrm>
            <a:off x="5861" y="597760"/>
            <a:ext cx="6861482" cy="6309360"/>
            <a:chOff x="5861" y="597760"/>
            <a:chExt cx="6861482" cy="630936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7C26B569-B1D3-C75E-27D6-38E89CFD0B0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861" y="4804000"/>
              <a:ext cx="3505199" cy="210312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28307FD-7F89-AED6-47FF-85A649B8220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348130" y="4804000"/>
              <a:ext cx="3500526" cy="210312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41787CE3-6EB4-D75B-9638-8AC6CB0290D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344" y="597760"/>
              <a:ext cx="3505199" cy="210312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4C4D6ACC-318E-893A-E55E-0C45CA39805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66816" y="597760"/>
              <a:ext cx="3500527" cy="210312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B21D0EB0-2E60-4E1A-1359-28CD1CA46EB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362145" y="2700880"/>
              <a:ext cx="3500527" cy="210312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5A2E4648-9D00-80C5-5D00-D9884786F61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016" y="2700880"/>
              <a:ext cx="3500527" cy="210312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352998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5</TotalTime>
  <Words>166</Words>
  <Application>Microsoft Office PowerPoint</Application>
  <PresentationFormat>On-screen Show (4:3)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Fondazione Edmund Ma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ca Populin</dc:creator>
  <cp:lastModifiedBy>Francesca Populin</cp:lastModifiedBy>
  <cp:revision>14</cp:revision>
  <dcterms:created xsi:type="dcterms:W3CDTF">2022-06-20T08:42:43Z</dcterms:created>
  <dcterms:modified xsi:type="dcterms:W3CDTF">2023-01-12T07:38:30Z</dcterms:modified>
</cp:coreProperties>
</file>